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2" r:id="rId2"/>
    <p:sldId id="263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50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26A644-CE0C-484D-8807-9E1604439508}" type="datetimeFigureOut">
              <a:rPr lang="de-CH" smtClean="0"/>
              <a:t>16.10.2021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41E22B-210B-4697-A873-7D5196BD94B3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7286340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26A644-CE0C-484D-8807-9E1604439508}" type="datetimeFigureOut">
              <a:rPr lang="de-CH" smtClean="0"/>
              <a:t>16.10.2021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41E22B-210B-4697-A873-7D5196BD94B3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1533797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26A644-CE0C-484D-8807-9E1604439508}" type="datetimeFigureOut">
              <a:rPr lang="de-CH" smtClean="0"/>
              <a:t>16.10.2021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41E22B-210B-4697-A873-7D5196BD94B3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4255300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26A644-CE0C-484D-8807-9E1604439508}" type="datetimeFigureOut">
              <a:rPr lang="de-CH" smtClean="0"/>
              <a:t>16.10.2021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41E22B-210B-4697-A873-7D5196BD94B3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8074900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26A644-CE0C-484D-8807-9E1604439508}" type="datetimeFigureOut">
              <a:rPr lang="de-CH" smtClean="0"/>
              <a:t>16.10.2021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41E22B-210B-4697-A873-7D5196BD94B3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2286902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26A644-CE0C-484D-8807-9E1604439508}" type="datetimeFigureOut">
              <a:rPr lang="de-CH" smtClean="0"/>
              <a:t>16.10.2021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41E22B-210B-4697-A873-7D5196BD94B3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7063371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26A644-CE0C-484D-8807-9E1604439508}" type="datetimeFigureOut">
              <a:rPr lang="de-CH" smtClean="0"/>
              <a:t>16.10.2021</a:t>
            </a:fld>
            <a:endParaRPr lang="de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41E22B-210B-4697-A873-7D5196BD94B3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0742105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26A644-CE0C-484D-8807-9E1604439508}" type="datetimeFigureOut">
              <a:rPr lang="de-CH" smtClean="0"/>
              <a:t>16.10.2021</a:t>
            </a:fld>
            <a:endParaRPr lang="de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41E22B-210B-4697-A873-7D5196BD94B3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8801332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26A644-CE0C-484D-8807-9E1604439508}" type="datetimeFigureOut">
              <a:rPr lang="de-CH" smtClean="0"/>
              <a:t>16.10.2021</a:t>
            </a:fld>
            <a:endParaRPr lang="de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41E22B-210B-4697-A873-7D5196BD94B3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818694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26A644-CE0C-484D-8807-9E1604439508}" type="datetimeFigureOut">
              <a:rPr lang="de-CH" smtClean="0"/>
              <a:t>16.10.2021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41E22B-210B-4697-A873-7D5196BD94B3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4566982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26A644-CE0C-484D-8807-9E1604439508}" type="datetimeFigureOut">
              <a:rPr lang="de-CH" smtClean="0"/>
              <a:t>16.10.2021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41E22B-210B-4697-A873-7D5196BD94B3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2707701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26A644-CE0C-484D-8807-9E1604439508}" type="datetimeFigureOut">
              <a:rPr lang="de-CH" smtClean="0"/>
              <a:t>16.10.2021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41E22B-210B-4697-A873-7D5196BD94B3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5943285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id="{ABC31DA9-5B39-4B54-9F3E-C4CE5FC2EAA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17552" y="699"/>
            <a:ext cx="5264092" cy="2770575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9AD45208-B040-4F4C-8356-9D1B54537410}"/>
              </a:ext>
            </a:extLst>
          </p:cNvPr>
          <p:cNvSpPr txBox="1"/>
          <p:nvPr/>
        </p:nvSpPr>
        <p:spPr>
          <a:xfrm>
            <a:off x="335560" y="260058"/>
            <a:ext cx="132177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b="1" dirty="0" err="1"/>
              <a:t>Supplementary</a:t>
            </a:r>
            <a:endParaRPr lang="de-CH" sz="1400" b="1" dirty="0"/>
          </a:p>
          <a:p>
            <a:r>
              <a:rPr lang="de-CH" sz="1400" b="1" dirty="0"/>
              <a:t>Figure 1</a:t>
            </a:r>
          </a:p>
        </p:txBody>
      </p:sp>
      <p:sp>
        <p:nvSpPr>
          <p:cNvPr id="5" name="Rechteck 4">
            <a:extLst>
              <a:ext uri="{FF2B5EF4-FFF2-40B4-BE49-F238E27FC236}">
                <a16:creationId xmlns:a16="http://schemas.microsoft.com/office/drawing/2014/main" id="{E9CFA718-25AE-4C47-B5D6-05A05FD506DA}"/>
              </a:ext>
            </a:extLst>
          </p:cNvPr>
          <p:cNvSpPr/>
          <p:nvPr/>
        </p:nvSpPr>
        <p:spPr>
          <a:xfrm>
            <a:off x="2612919" y="1895586"/>
            <a:ext cx="4207079" cy="9439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0C1EE0C5-1B51-4C60-B19A-AE2AD7B94283}"/>
              </a:ext>
            </a:extLst>
          </p:cNvPr>
          <p:cNvSpPr txBox="1"/>
          <p:nvPr/>
        </p:nvSpPr>
        <p:spPr>
          <a:xfrm>
            <a:off x="5931017" y="260058"/>
            <a:ext cx="6537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/>
              <a:t>Pat 1</a:t>
            </a:r>
          </a:p>
        </p:txBody>
      </p:sp>
      <p:sp>
        <p:nvSpPr>
          <p:cNvPr id="15" name="Rechteck 14">
            <a:extLst>
              <a:ext uri="{FF2B5EF4-FFF2-40B4-BE49-F238E27FC236}">
                <a16:creationId xmlns:a16="http://schemas.microsoft.com/office/drawing/2014/main" id="{9FC7DDAA-9FC4-415C-9F4B-B833304BD2A1}"/>
              </a:ext>
            </a:extLst>
          </p:cNvPr>
          <p:cNvSpPr/>
          <p:nvPr/>
        </p:nvSpPr>
        <p:spPr>
          <a:xfrm>
            <a:off x="3833769" y="5629013"/>
            <a:ext cx="167780" cy="8556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FBFE93A0-73CA-43B0-9C07-C7D09DC3FB8A}"/>
              </a:ext>
            </a:extLst>
          </p:cNvPr>
          <p:cNvSpPr txBox="1"/>
          <p:nvPr/>
        </p:nvSpPr>
        <p:spPr>
          <a:xfrm>
            <a:off x="4077869" y="260058"/>
            <a:ext cx="934871" cy="26161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de-CH" sz="1100" dirty="0" err="1"/>
              <a:t>Stop</a:t>
            </a:r>
            <a:r>
              <a:rPr lang="de-CH" sz="1100" dirty="0"/>
              <a:t> IS: d329</a:t>
            </a:r>
          </a:p>
        </p:txBody>
      </p:sp>
      <p:pic>
        <p:nvPicPr>
          <p:cNvPr id="6" name="Grafik 5">
            <a:extLst>
              <a:ext uri="{FF2B5EF4-FFF2-40B4-BE49-F238E27FC236}">
                <a16:creationId xmlns:a16="http://schemas.microsoft.com/office/drawing/2014/main" id="{F2D485F2-8FDB-4305-A6F0-A059996A4F5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09163" y="1838256"/>
            <a:ext cx="5285863" cy="2782032"/>
          </a:xfrm>
          <a:prstGeom prst="rect">
            <a:avLst/>
          </a:prstGeom>
        </p:spPr>
      </p:pic>
      <p:sp>
        <p:nvSpPr>
          <p:cNvPr id="11" name="Textfeld 10">
            <a:extLst>
              <a:ext uri="{FF2B5EF4-FFF2-40B4-BE49-F238E27FC236}">
                <a16:creationId xmlns:a16="http://schemas.microsoft.com/office/drawing/2014/main" id="{5CB4AC7A-E59B-46FB-B082-8F5C48401D29}"/>
              </a:ext>
            </a:extLst>
          </p:cNvPr>
          <p:cNvSpPr txBox="1"/>
          <p:nvPr/>
        </p:nvSpPr>
        <p:spPr>
          <a:xfrm>
            <a:off x="5931017" y="2368805"/>
            <a:ext cx="6537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/>
              <a:t>Pat 2</a:t>
            </a: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02EEE9EF-4E5E-4CFE-A595-5BB8C00B19E5}"/>
              </a:ext>
            </a:extLst>
          </p:cNvPr>
          <p:cNvSpPr txBox="1"/>
          <p:nvPr/>
        </p:nvSpPr>
        <p:spPr>
          <a:xfrm>
            <a:off x="5686266" y="2036664"/>
            <a:ext cx="934871" cy="26161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de-CH" sz="1100" dirty="0" err="1"/>
              <a:t>Stop</a:t>
            </a:r>
            <a:r>
              <a:rPr lang="de-CH" sz="1100" dirty="0"/>
              <a:t> IS: d749</a:t>
            </a:r>
          </a:p>
        </p:txBody>
      </p:sp>
      <p:sp>
        <p:nvSpPr>
          <p:cNvPr id="9" name="Rechteck 8">
            <a:extLst>
              <a:ext uri="{FF2B5EF4-FFF2-40B4-BE49-F238E27FC236}">
                <a16:creationId xmlns:a16="http://schemas.microsoft.com/office/drawing/2014/main" id="{5A89A687-441A-4D97-87DA-29155F7B1158}"/>
              </a:ext>
            </a:extLst>
          </p:cNvPr>
          <p:cNvSpPr/>
          <p:nvPr/>
        </p:nvSpPr>
        <p:spPr>
          <a:xfrm>
            <a:off x="2546058" y="3758320"/>
            <a:ext cx="4207079" cy="9439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pic>
        <p:nvPicPr>
          <p:cNvPr id="7" name="Grafik 6">
            <a:extLst>
              <a:ext uri="{FF2B5EF4-FFF2-40B4-BE49-F238E27FC236}">
                <a16:creationId xmlns:a16="http://schemas.microsoft.com/office/drawing/2014/main" id="{47E1AA76-A616-4835-B167-62B273B49C7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01473" y="3765855"/>
            <a:ext cx="5293554" cy="3012450"/>
          </a:xfrm>
          <a:prstGeom prst="rect">
            <a:avLst/>
          </a:prstGeom>
        </p:spPr>
      </p:pic>
      <p:sp>
        <p:nvSpPr>
          <p:cNvPr id="12" name="Textfeld 11">
            <a:extLst>
              <a:ext uri="{FF2B5EF4-FFF2-40B4-BE49-F238E27FC236}">
                <a16:creationId xmlns:a16="http://schemas.microsoft.com/office/drawing/2014/main" id="{C5DF5B86-7F74-473E-8E82-A13C36E9F6DC}"/>
              </a:ext>
            </a:extLst>
          </p:cNvPr>
          <p:cNvSpPr txBox="1"/>
          <p:nvPr/>
        </p:nvSpPr>
        <p:spPr>
          <a:xfrm>
            <a:off x="5931016" y="3932267"/>
            <a:ext cx="6537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/>
              <a:t>Pat 3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810F03BA-F841-40D3-ACF8-55CD6585C345}"/>
              </a:ext>
            </a:extLst>
          </p:cNvPr>
          <p:cNvSpPr txBox="1"/>
          <p:nvPr/>
        </p:nvSpPr>
        <p:spPr>
          <a:xfrm>
            <a:off x="4516476" y="3998044"/>
            <a:ext cx="934871" cy="26161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de-CH" sz="1100" dirty="0" err="1"/>
              <a:t>Stop</a:t>
            </a:r>
            <a:r>
              <a:rPr lang="de-CH" sz="1100" dirty="0"/>
              <a:t> IS: d444</a:t>
            </a:r>
          </a:p>
        </p:txBody>
      </p:sp>
      <p:sp>
        <p:nvSpPr>
          <p:cNvPr id="18" name="Rechteck 17">
            <a:extLst>
              <a:ext uri="{FF2B5EF4-FFF2-40B4-BE49-F238E27FC236}">
                <a16:creationId xmlns:a16="http://schemas.microsoft.com/office/drawing/2014/main" id="{540177E2-4D47-4611-A151-BCAF012A4719}"/>
              </a:ext>
            </a:extLst>
          </p:cNvPr>
          <p:cNvSpPr/>
          <p:nvPr/>
        </p:nvSpPr>
        <p:spPr>
          <a:xfrm>
            <a:off x="4449364" y="5689270"/>
            <a:ext cx="167780" cy="79542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9700233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511F1954-E7DF-48B3-A3AF-1F66EE5C42A8}"/>
              </a:ext>
            </a:extLst>
          </p:cNvPr>
          <p:cNvSpPr txBox="1"/>
          <p:nvPr/>
        </p:nvSpPr>
        <p:spPr>
          <a:xfrm>
            <a:off x="838900" y="1333850"/>
            <a:ext cx="7097086" cy="12208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1">
              <a:spcBef>
                <a:spcPts val="1200"/>
              </a:spcBef>
              <a:spcAft>
                <a:spcPts val="10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mbria" panose="02040503050406030204" pitchFamily="18" charset="0"/>
              </a:rPr>
              <a:t>Supplementary Fig. 1  Synopsis of immunosuppression over time</a:t>
            </a:r>
            <a:endParaRPr lang="de-CH" sz="1200" b="1" dirty="0">
              <a:effectLst/>
              <a:latin typeface="Times New Roman" panose="02020603050405020304" pitchFamily="18" charset="0"/>
              <a:ea typeface="Cambria" panose="02040503050406030204" pitchFamily="18" charset="0"/>
            </a:endParaRPr>
          </a:p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level of immunosuppressive treatment is shown over time for all three recipients. Mycophenolate mofetil (MMF) and prednisone (PDN) are indicated in mg/d. Cyclosporine is indicated with trough levels (C0) in µg/l. Dotted lines indicate time intervals of 6 and 12 months post-transplant and yearly thereafter. The hatched line indicates the time point of stop of all immunosuppressive treatment (IS).</a:t>
            </a:r>
            <a:endParaRPr lang="de-CH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750338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06</Words>
  <Application>Microsoft Office PowerPoint</Application>
  <PresentationFormat>Bildschirmpräsentation (4:3)</PresentationFormat>
  <Paragraphs>10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Thomas Fehr</dc:creator>
  <cp:lastModifiedBy>Thomas Fehr</cp:lastModifiedBy>
  <cp:revision>30</cp:revision>
  <dcterms:created xsi:type="dcterms:W3CDTF">2021-09-12T15:40:35Z</dcterms:created>
  <dcterms:modified xsi:type="dcterms:W3CDTF">2021-10-16T16:28:45Z</dcterms:modified>
</cp:coreProperties>
</file>